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2DD97B5-BB0B-493A-88EF-4F524A047145}" v="1" dt="2021-07-09T11:34:31.56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409" autoAdjust="0"/>
    <p:restoredTop sz="96208"/>
  </p:normalViewPr>
  <p:slideViewPr>
    <p:cSldViewPr snapToGrid="0" snapToObjects="1">
      <p:cViewPr varScale="1">
        <p:scale>
          <a:sx n="101" d="100"/>
          <a:sy n="101" d="100"/>
        </p:scale>
        <p:origin x="192" y="2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ester, Alice" userId="3488f9a2-0bc7-4793-a012-c42597f005ea" providerId="ADAL" clId="{22DD97B5-BB0B-493A-88EF-4F524A047145}"/>
    <pc:docChg chg="custSel modSld">
      <pc:chgData name="Lester, Alice" userId="3488f9a2-0bc7-4793-a012-c42597f005ea" providerId="ADAL" clId="{22DD97B5-BB0B-493A-88EF-4F524A047145}" dt="2021-07-09T11:37:12.535" v="175" actId="20577"/>
      <pc:docMkLst>
        <pc:docMk/>
      </pc:docMkLst>
      <pc:sldChg chg="addSp delSp modSp mod">
        <pc:chgData name="Lester, Alice" userId="3488f9a2-0bc7-4793-a012-c42597f005ea" providerId="ADAL" clId="{22DD97B5-BB0B-493A-88EF-4F524A047145}" dt="2021-07-09T11:37:12.535" v="175" actId="20577"/>
        <pc:sldMkLst>
          <pc:docMk/>
          <pc:sldMk cId="61558962" sldId="256"/>
        </pc:sldMkLst>
        <pc:spChg chg="add mod">
          <ac:chgData name="Lester, Alice" userId="3488f9a2-0bc7-4793-a012-c42597f005ea" providerId="ADAL" clId="{22DD97B5-BB0B-493A-88EF-4F524A047145}" dt="2021-07-09T11:37:12.535" v="175" actId="20577"/>
          <ac:spMkLst>
            <pc:docMk/>
            <pc:sldMk cId="61558962" sldId="256"/>
            <ac:spMk id="2" creationId="{C02933B5-849B-46DC-A933-ED2D0F0E14A4}"/>
          </ac:spMkLst>
        </pc:spChg>
        <pc:spChg chg="mod">
          <ac:chgData name="Lester, Alice" userId="3488f9a2-0bc7-4793-a012-c42597f005ea" providerId="ADAL" clId="{22DD97B5-BB0B-493A-88EF-4F524A047145}" dt="2021-07-09T11:34:15.470" v="98" actId="1036"/>
          <ac:spMkLst>
            <pc:docMk/>
            <pc:sldMk cId="61558962" sldId="256"/>
            <ac:spMk id="4" creationId="{37C27077-ED97-A742-A934-956B2B0357E2}"/>
          </ac:spMkLst>
        </pc:spChg>
        <pc:spChg chg="mod">
          <ac:chgData name="Lester, Alice" userId="3488f9a2-0bc7-4793-a012-c42597f005ea" providerId="ADAL" clId="{22DD97B5-BB0B-493A-88EF-4F524A047145}" dt="2021-07-09T11:34:22.013" v="117" actId="1035"/>
          <ac:spMkLst>
            <pc:docMk/>
            <pc:sldMk cId="61558962" sldId="256"/>
            <ac:spMk id="5" creationId="{2BB66600-AC4F-DE4E-9AF4-D919A059A21D}"/>
          </ac:spMkLst>
        </pc:spChg>
        <pc:spChg chg="mod">
          <ac:chgData name="Lester, Alice" userId="3488f9a2-0bc7-4793-a012-c42597f005ea" providerId="ADAL" clId="{22DD97B5-BB0B-493A-88EF-4F524A047145}" dt="2021-07-09T11:34:15.470" v="98" actId="1036"/>
          <ac:spMkLst>
            <pc:docMk/>
            <pc:sldMk cId="61558962" sldId="256"/>
            <ac:spMk id="7" creationId="{DACAA21D-1AFA-4C47-BE6E-7CDED85A848D}"/>
          </ac:spMkLst>
        </pc:spChg>
        <pc:spChg chg="mod">
          <ac:chgData name="Lester, Alice" userId="3488f9a2-0bc7-4793-a012-c42597f005ea" providerId="ADAL" clId="{22DD97B5-BB0B-493A-88EF-4F524A047145}" dt="2021-07-09T11:33:45.484" v="63" actId="1035"/>
          <ac:spMkLst>
            <pc:docMk/>
            <pc:sldMk cId="61558962" sldId="256"/>
            <ac:spMk id="12" creationId="{49433337-BA49-1843-BB61-52221D572AFB}"/>
          </ac:spMkLst>
        </pc:spChg>
        <pc:spChg chg="mod">
          <ac:chgData name="Lester, Alice" userId="3488f9a2-0bc7-4793-a012-c42597f005ea" providerId="ADAL" clId="{22DD97B5-BB0B-493A-88EF-4F524A047145}" dt="2021-07-09T11:33:45.484" v="63" actId="1035"/>
          <ac:spMkLst>
            <pc:docMk/>
            <pc:sldMk cId="61558962" sldId="256"/>
            <ac:spMk id="13" creationId="{7927FBB8-AE6C-5440-A9BF-17DF9D31A044}"/>
          </ac:spMkLst>
        </pc:spChg>
        <pc:spChg chg="mod">
          <ac:chgData name="Lester, Alice" userId="3488f9a2-0bc7-4793-a012-c42597f005ea" providerId="ADAL" clId="{22DD97B5-BB0B-493A-88EF-4F524A047145}" dt="2021-07-09T11:33:45.484" v="63" actId="1035"/>
          <ac:spMkLst>
            <pc:docMk/>
            <pc:sldMk cId="61558962" sldId="256"/>
            <ac:spMk id="14" creationId="{A0E00467-C636-774B-A1BC-E53DBC4A7B0D}"/>
          </ac:spMkLst>
        </pc:spChg>
        <pc:spChg chg="mod">
          <ac:chgData name="Lester, Alice" userId="3488f9a2-0bc7-4793-a012-c42597f005ea" providerId="ADAL" clId="{22DD97B5-BB0B-493A-88EF-4F524A047145}" dt="2021-07-09T11:33:45.484" v="63" actId="1035"/>
          <ac:spMkLst>
            <pc:docMk/>
            <pc:sldMk cId="61558962" sldId="256"/>
            <ac:spMk id="15" creationId="{635305E8-B66D-CF4C-8199-7EB7DCF423F6}"/>
          </ac:spMkLst>
        </pc:spChg>
        <pc:spChg chg="mod">
          <ac:chgData name="Lester, Alice" userId="3488f9a2-0bc7-4793-a012-c42597f005ea" providerId="ADAL" clId="{22DD97B5-BB0B-493A-88EF-4F524A047145}" dt="2021-07-09T11:33:45.484" v="63" actId="1035"/>
          <ac:spMkLst>
            <pc:docMk/>
            <pc:sldMk cId="61558962" sldId="256"/>
            <ac:spMk id="18" creationId="{58EC5714-0AA5-A94A-9E1A-15260F5AC35C}"/>
          </ac:spMkLst>
        </pc:spChg>
        <pc:spChg chg="mod">
          <ac:chgData name="Lester, Alice" userId="3488f9a2-0bc7-4793-a012-c42597f005ea" providerId="ADAL" clId="{22DD97B5-BB0B-493A-88EF-4F524A047145}" dt="2021-07-09T11:33:59.387" v="76" actId="1035"/>
          <ac:spMkLst>
            <pc:docMk/>
            <pc:sldMk cId="61558962" sldId="256"/>
            <ac:spMk id="19" creationId="{13D711DD-F66D-764F-997A-F3751DD069E3}"/>
          </ac:spMkLst>
        </pc:spChg>
        <pc:spChg chg="mod">
          <ac:chgData name="Lester, Alice" userId="3488f9a2-0bc7-4793-a012-c42597f005ea" providerId="ADAL" clId="{22DD97B5-BB0B-493A-88EF-4F524A047145}" dt="2021-07-09T11:33:45.484" v="63" actId="1035"/>
          <ac:spMkLst>
            <pc:docMk/>
            <pc:sldMk cId="61558962" sldId="256"/>
            <ac:spMk id="20" creationId="{967CDFA8-ED1C-5643-9D72-1CBB62FD859C}"/>
          </ac:spMkLst>
        </pc:spChg>
        <pc:spChg chg="mod">
          <ac:chgData name="Lester, Alice" userId="3488f9a2-0bc7-4793-a012-c42597f005ea" providerId="ADAL" clId="{22DD97B5-BB0B-493A-88EF-4F524A047145}" dt="2021-07-09T11:33:45.484" v="63" actId="1035"/>
          <ac:spMkLst>
            <pc:docMk/>
            <pc:sldMk cId="61558962" sldId="256"/>
            <ac:spMk id="21" creationId="{53B1B4ED-755B-0E4A-AF5D-D7D4191D02F4}"/>
          </ac:spMkLst>
        </pc:spChg>
        <pc:spChg chg="mod">
          <ac:chgData name="Lester, Alice" userId="3488f9a2-0bc7-4793-a012-c42597f005ea" providerId="ADAL" clId="{22DD97B5-BB0B-493A-88EF-4F524A047145}" dt="2021-07-09T11:33:59.387" v="76" actId="1035"/>
          <ac:spMkLst>
            <pc:docMk/>
            <pc:sldMk cId="61558962" sldId="256"/>
            <ac:spMk id="22" creationId="{34B23353-9B1E-9F4D-A4EC-2A2056CD507E}"/>
          </ac:spMkLst>
        </pc:spChg>
        <pc:spChg chg="mod">
          <ac:chgData name="Lester, Alice" userId="3488f9a2-0bc7-4793-a012-c42597f005ea" providerId="ADAL" clId="{22DD97B5-BB0B-493A-88EF-4F524A047145}" dt="2021-07-09T11:33:45.484" v="63" actId="1035"/>
          <ac:spMkLst>
            <pc:docMk/>
            <pc:sldMk cId="61558962" sldId="256"/>
            <ac:spMk id="23" creationId="{F2D5BBD3-46DE-EF42-BA71-3610069A746D}"/>
          </ac:spMkLst>
        </pc:spChg>
        <pc:spChg chg="mod">
          <ac:chgData name="Lester, Alice" userId="3488f9a2-0bc7-4793-a012-c42597f005ea" providerId="ADAL" clId="{22DD97B5-BB0B-493A-88EF-4F524A047145}" dt="2021-07-09T11:33:45.484" v="63" actId="1035"/>
          <ac:spMkLst>
            <pc:docMk/>
            <pc:sldMk cId="61558962" sldId="256"/>
            <ac:spMk id="24" creationId="{E3F0228B-0394-8E4D-B5FB-1F604593B172}"/>
          </ac:spMkLst>
        </pc:spChg>
        <pc:spChg chg="mod">
          <ac:chgData name="Lester, Alice" userId="3488f9a2-0bc7-4793-a012-c42597f005ea" providerId="ADAL" clId="{22DD97B5-BB0B-493A-88EF-4F524A047145}" dt="2021-07-09T11:33:45.484" v="63" actId="1035"/>
          <ac:spMkLst>
            <pc:docMk/>
            <pc:sldMk cId="61558962" sldId="256"/>
            <ac:spMk id="27" creationId="{736C2FB6-B0F6-5F47-8259-1E45AE54E154}"/>
          </ac:spMkLst>
        </pc:spChg>
        <pc:spChg chg="mod">
          <ac:chgData name="Lester, Alice" userId="3488f9a2-0bc7-4793-a012-c42597f005ea" providerId="ADAL" clId="{22DD97B5-BB0B-493A-88EF-4F524A047145}" dt="2021-07-09T11:33:59.387" v="76" actId="1035"/>
          <ac:spMkLst>
            <pc:docMk/>
            <pc:sldMk cId="61558962" sldId="256"/>
            <ac:spMk id="28" creationId="{E6A42009-361A-F94A-AFBC-BFE602C05C6C}"/>
          </ac:spMkLst>
        </pc:spChg>
        <pc:spChg chg="mod">
          <ac:chgData name="Lester, Alice" userId="3488f9a2-0bc7-4793-a012-c42597f005ea" providerId="ADAL" clId="{22DD97B5-BB0B-493A-88EF-4F524A047145}" dt="2021-07-09T11:33:59.387" v="76" actId="1035"/>
          <ac:spMkLst>
            <pc:docMk/>
            <pc:sldMk cId="61558962" sldId="256"/>
            <ac:spMk id="31" creationId="{828CC8D2-48CD-1E45-B4F1-4A69BF460A66}"/>
          </ac:spMkLst>
        </pc:spChg>
        <pc:spChg chg="mod">
          <ac:chgData name="Lester, Alice" userId="3488f9a2-0bc7-4793-a012-c42597f005ea" providerId="ADAL" clId="{22DD97B5-BB0B-493A-88EF-4F524A047145}" dt="2021-07-09T11:33:59.387" v="76" actId="1035"/>
          <ac:spMkLst>
            <pc:docMk/>
            <pc:sldMk cId="61558962" sldId="256"/>
            <ac:spMk id="32" creationId="{1F9959CC-3028-1443-93DF-1DF0E4CCBD88}"/>
          </ac:spMkLst>
        </pc:spChg>
        <pc:spChg chg="mod">
          <ac:chgData name="Lester, Alice" userId="3488f9a2-0bc7-4793-a012-c42597f005ea" providerId="ADAL" clId="{22DD97B5-BB0B-493A-88EF-4F524A047145}" dt="2021-07-09T11:33:45.484" v="63" actId="1035"/>
          <ac:spMkLst>
            <pc:docMk/>
            <pc:sldMk cId="61558962" sldId="256"/>
            <ac:spMk id="34" creationId="{F5637A9B-0192-754D-93AE-3463389DDBC9}"/>
          </ac:spMkLst>
        </pc:spChg>
        <pc:spChg chg="mod">
          <ac:chgData name="Lester, Alice" userId="3488f9a2-0bc7-4793-a012-c42597f005ea" providerId="ADAL" clId="{22DD97B5-BB0B-493A-88EF-4F524A047145}" dt="2021-07-09T11:33:45.484" v="63" actId="1035"/>
          <ac:spMkLst>
            <pc:docMk/>
            <pc:sldMk cId="61558962" sldId="256"/>
            <ac:spMk id="35" creationId="{DB367C68-B7BE-8842-A71E-321F98B6A4D2}"/>
          </ac:spMkLst>
        </pc:spChg>
        <pc:spChg chg="mod">
          <ac:chgData name="Lester, Alice" userId="3488f9a2-0bc7-4793-a012-c42597f005ea" providerId="ADAL" clId="{22DD97B5-BB0B-493A-88EF-4F524A047145}" dt="2021-07-09T11:33:45.484" v="63" actId="1035"/>
          <ac:spMkLst>
            <pc:docMk/>
            <pc:sldMk cId="61558962" sldId="256"/>
            <ac:spMk id="36" creationId="{1AD97018-F7CD-AC4C-9B72-4792A432D5CF}"/>
          </ac:spMkLst>
        </pc:spChg>
        <pc:spChg chg="mod">
          <ac:chgData name="Lester, Alice" userId="3488f9a2-0bc7-4793-a012-c42597f005ea" providerId="ADAL" clId="{22DD97B5-BB0B-493A-88EF-4F524A047145}" dt="2021-07-09T11:33:45.484" v="63" actId="1035"/>
          <ac:spMkLst>
            <pc:docMk/>
            <pc:sldMk cId="61558962" sldId="256"/>
            <ac:spMk id="39" creationId="{68B9772A-F154-234A-9961-00344510CB86}"/>
          </ac:spMkLst>
        </pc:spChg>
        <pc:spChg chg="mod">
          <ac:chgData name="Lester, Alice" userId="3488f9a2-0bc7-4793-a012-c42597f005ea" providerId="ADAL" clId="{22DD97B5-BB0B-493A-88EF-4F524A047145}" dt="2021-07-09T11:33:45.484" v="63" actId="1035"/>
          <ac:spMkLst>
            <pc:docMk/>
            <pc:sldMk cId="61558962" sldId="256"/>
            <ac:spMk id="42" creationId="{88E0150E-9FC4-834B-A0F0-63C3F6E314FB}"/>
          </ac:spMkLst>
        </pc:spChg>
        <pc:spChg chg="mod">
          <ac:chgData name="Lester, Alice" userId="3488f9a2-0bc7-4793-a012-c42597f005ea" providerId="ADAL" clId="{22DD97B5-BB0B-493A-88EF-4F524A047145}" dt="2021-07-09T11:33:45.484" v="63" actId="1035"/>
          <ac:spMkLst>
            <pc:docMk/>
            <pc:sldMk cId="61558962" sldId="256"/>
            <ac:spMk id="45" creationId="{A19481F2-A56C-C346-A1E8-26E31FBBE82A}"/>
          </ac:spMkLst>
        </pc:spChg>
        <pc:spChg chg="mod">
          <ac:chgData name="Lester, Alice" userId="3488f9a2-0bc7-4793-a012-c42597f005ea" providerId="ADAL" clId="{22DD97B5-BB0B-493A-88EF-4F524A047145}" dt="2021-07-09T11:33:45.484" v="63" actId="1035"/>
          <ac:spMkLst>
            <pc:docMk/>
            <pc:sldMk cId="61558962" sldId="256"/>
            <ac:spMk id="46" creationId="{9C9455CF-5A76-0C49-969D-A6A22128FF0D}"/>
          </ac:spMkLst>
        </pc:spChg>
        <pc:spChg chg="mod">
          <ac:chgData name="Lester, Alice" userId="3488f9a2-0bc7-4793-a012-c42597f005ea" providerId="ADAL" clId="{22DD97B5-BB0B-493A-88EF-4F524A047145}" dt="2021-07-09T11:33:45.484" v="63" actId="1035"/>
          <ac:spMkLst>
            <pc:docMk/>
            <pc:sldMk cId="61558962" sldId="256"/>
            <ac:spMk id="47" creationId="{959A0764-3401-A447-8656-90777658E23A}"/>
          </ac:spMkLst>
        </pc:spChg>
        <pc:spChg chg="mod">
          <ac:chgData name="Lester, Alice" userId="3488f9a2-0bc7-4793-a012-c42597f005ea" providerId="ADAL" clId="{22DD97B5-BB0B-493A-88EF-4F524A047145}" dt="2021-07-09T11:33:59.387" v="76" actId="1035"/>
          <ac:spMkLst>
            <pc:docMk/>
            <pc:sldMk cId="61558962" sldId="256"/>
            <ac:spMk id="49" creationId="{7F95FB64-D51A-6B4B-A034-3E2CC2187AD1}"/>
          </ac:spMkLst>
        </pc:spChg>
        <pc:spChg chg="mod">
          <ac:chgData name="Lester, Alice" userId="3488f9a2-0bc7-4793-a012-c42597f005ea" providerId="ADAL" clId="{22DD97B5-BB0B-493A-88EF-4F524A047145}" dt="2021-07-09T11:33:59.387" v="76" actId="1035"/>
          <ac:spMkLst>
            <pc:docMk/>
            <pc:sldMk cId="61558962" sldId="256"/>
            <ac:spMk id="52" creationId="{F6EC5191-83B8-F74E-BEC0-D23833F0F022}"/>
          </ac:spMkLst>
        </pc:spChg>
        <pc:spChg chg="mod">
          <ac:chgData name="Lester, Alice" userId="3488f9a2-0bc7-4793-a012-c42597f005ea" providerId="ADAL" clId="{22DD97B5-BB0B-493A-88EF-4F524A047145}" dt="2021-07-09T11:33:59.387" v="76" actId="1035"/>
          <ac:spMkLst>
            <pc:docMk/>
            <pc:sldMk cId="61558962" sldId="256"/>
            <ac:spMk id="53" creationId="{7CFBFBB3-EC76-7C44-A3F4-A083465EF323}"/>
          </ac:spMkLst>
        </pc:spChg>
        <pc:spChg chg="mod">
          <ac:chgData name="Lester, Alice" userId="3488f9a2-0bc7-4793-a012-c42597f005ea" providerId="ADAL" clId="{22DD97B5-BB0B-493A-88EF-4F524A047145}" dt="2021-07-09T11:33:59.387" v="76" actId="1035"/>
          <ac:spMkLst>
            <pc:docMk/>
            <pc:sldMk cId="61558962" sldId="256"/>
            <ac:spMk id="54" creationId="{51CEDEFB-FD38-AF4C-B7EB-B26402F23516}"/>
          </ac:spMkLst>
        </pc:spChg>
        <pc:spChg chg="mod">
          <ac:chgData name="Lester, Alice" userId="3488f9a2-0bc7-4793-a012-c42597f005ea" providerId="ADAL" clId="{22DD97B5-BB0B-493A-88EF-4F524A047145}" dt="2021-07-09T11:33:45.484" v="63" actId="1035"/>
          <ac:spMkLst>
            <pc:docMk/>
            <pc:sldMk cId="61558962" sldId="256"/>
            <ac:spMk id="55" creationId="{30122387-E1B4-3F4C-99E2-A1A8990879C7}"/>
          </ac:spMkLst>
        </pc:spChg>
        <pc:spChg chg="mod">
          <ac:chgData name="Lester, Alice" userId="3488f9a2-0bc7-4793-a012-c42597f005ea" providerId="ADAL" clId="{22DD97B5-BB0B-493A-88EF-4F524A047145}" dt="2021-07-09T11:33:45.484" v="63" actId="1035"/>
          <ac:spMkLst>
            <pc:docMk/>
            <pc:sldMk cId="61558962" sldId="256"/>
            <ac:spMk id="56" creationId="{FD66483F-9E84-E940-84AB-641A47080BCE}"/>
          </ac:spMkLst>
        </pc:spChg>
        <pc:spChg chg="mod">
          <ac:chgData name="Lester, Alice" userId="3488f9a2-0bc7-4793-a012-c42597f005ea" providerId="ADAL" clId="{22DD97B5-BB0B-493A-88EF-4F524A047145}" dt="2021-07-09T11:33:59.387" v="76" actId="1035"/>
          <ac:spMkLst>
            <pc:docMk/>
            <pc:sldMk cId="61558962" sldId="256"/>
            <ac:spMk id="57" creationId="{8697A56B-45C5-0449-AF4F-763306A2DD77}"/>
          </ac:spMkLst>
        </pc:spChg>
        <pc:spChg chg="del">
          <ac:chgData name="Lester, Alice" userId="3488f9a2-0bc7-4793-a012-c42597f005ea" providerId="ADAL" clId="{22DD97B5-BB0B-493A-88EF-4F524A047145}" dt="2021-07-08T17:19:01.162" v="24" actId="478"/>
          <ac:spMkLst>
            <pc:docMk/>
            <pc:sldMk cId="61558962" sldId="256"/>
            <ac:spMk id="58" creationId="{FDC69FD0-59F6-C64E-9C9F-4AE094195902}"/>
          </ac:spMkLst>
        </pc:spChg>
        <pc:picChg chg="mod">
          <ac:chgData name="Lester, Alice" userId="3488f9a2-0bc7-4793-a012-c42597f005ea" providerId="ADAL" clId="{22DD97B5-BB0B-493A-88EF-4F524A047145}" dt="2021-07-09T11:34:07.523" v="77" actId="1076"/>
          <ac:picMkLst>
            <pc:docMk/>
            <pc:sldMk cId="61558962" sldId="256"/>
            <ac:picMk id="6" creationId="{62E25A6A-F788-7E4C-9A22-F6BDDE354997}"/>
          </ac:picMkLst>
        </pc:picChg>
        <pc:picChg chg="mod">
          <ac:chgData name="Lester, Alice" userId="3488f9a2-0bc7-4793-a012-c42597f005ea" providerId="ADAL" clId="{22DD97B5-BB0B-493A-88EF-4F524A047145}" dt="2021-07-09T11:33:45.484" v="63" actId="1035"/>
          <ac:picMkLst>
            <pc:docMk/>
            <pc:sldMk cId="61558962" sldId="256"/>
            <ac:picMk id="8" creationId="{1E004FD1-2668-7C4F-8744-C4A228A4C3C6}"/>
          </ac:picMkLst>
        </pc:picChg>
        <pc:picChg chg="mod">
          <ac:chgData name="Lester, Alice" userId="3488f9a2-0bc7-4793-a012-c42597f005ea" providerId="ADAL" clId="{22DD97B5-BB0B-493A-88EF-4F524A047145}" dt="2021-07-09T11:33:45.484" v="63" actId="1035"/>
          <ac:picMkLst>
            <pc:docMk/>
            <pc:sldMk cId="61558962" sldId="256"/>
            <ac:picMk id="9" creationId="{3C0EF23F-3BBE-A646-93F5-B9F8870F4110}"/>
          </ac:picMkLst>
        </pc:picChg>
        <pc:picChg chg="mod">
          <ac:chgData name="Lester, Alice" userId="3488f9a2-0bc7-4793-a012-c42597f005ea" providerId="ADAL" clId="{22DD97B5-BB0B-493A-88EF-4F524A047145}" dt="2021-07-09T11:33:59.387" v="76" actId="1035"/>
          <ac:picMkLst>
            <pc:docMk/>
            <pc:sldMk cId="61558962" sldId="256"/>
            <ac:picMk id="10" creationId="{CC33927B-0CFA-E54D-A7D0-84C610FCCBD5}"/>
          </ac:picMkLst>
        </pc:picChg>
        <pc:picChg chg="mod">
          <ac:chgData name="Lester, Alice" userId="3488f9a2-0bc7-4793-a012-c42597f005ea" providerId="ADAL" clId="{22DD97B5-BB0B-493A-88EF-4F524A047145}" dt="2021-07-09T11:33:45.484" v="63" actId="1035"/>
          <ac:picMkLst>
            <pc:docMk/>
            <pc:sldMk cId="61558962" sldId="256"/>
            <ac:picMk id="16" creationId="{1D726E6E-6D2B-5D4E-999E-4DE0C46E90E1}"/>
          </ac:picMkLst>
        </pc:picChg>
        <pc:picChg chg="mod">
          <ac:chgData name="Lester, Alice" userId="3488f9a2-0bc7-4793-a012-c42597f005ea" providerId="ADAL" clId="{22DD97B5-BB0B-493A-88EF-4F524A047145}" dt="2021-07-09T11:33:45.484" v="63" actId="1035"/>
          <ac:picMkLst>
            <pc:docMk/>
            <pc:sldMk cId="61558962" sldId="256"/>
            <ac:picMk id="17" creationId="{7F256820-5BCB-E247-B430-7F146D97703F}"/>
          </ac:picMkLst>
        </pc:picChg>
        <pc:picChg chg="mod">
          <ac:chgData name="Lester, Alice" userId="3488f9a2-0bc7-4793-a012-c42597f005ea" providerId="ADAL" clId="{22DD97B5-BB0B-493A-88EF-4F524A047145}" dt="2021-07-09T11:33:45.484" v="63" actId="1035"/>
          <ac:picMkLst>
            <pc:docMk/>
            <pc:sldMk cId="61558962" sldId="256"/>
            <ac:picMk id="25" creationId="{9C710974-4E21-DB4F-9781-F939653FDF37}"/>
          </ac:picMkLst>
        </pc:picChg>
        <pc:picChg chg="mod">
          <ac:chgData name="Lester, Alice" userId="3488f9a2-0bc7-4793-a012-c42597f005ea" providerId="ADAL" clId="{22DD97B5-BB0B-493A-88EF-4F524A047145}" dt="2021-07-09T11:33:45.484" v="63" actId="1035"/>
          <ac:picMkLst>
            <pc:docMk/>
            <pc:sldMk cId="61558962" sldId="256"/>
            <ac:picMk id="26" creationId="{7B8EAF02-A305-7342-BBF5-D0943D94B6ED}"/>
          </ac:picMkLst>
        </pc:picChg>
        <pc:picChg chg="mod">
          <ac:chgData name="Lester, Alice" userId="3488f9a2-0bc7-4793-a012-c42597f005ea" providerId="ADAL" clId="{22DD97B5-BB0B-493A-88EF-4F524A047145}" dt="2021-07-09T11:33:59.387" v="76" actId="1035"/>
          <ac:picMkLst>
            <pc:docMk/>
            <pc:sldMk cId="61558962" sldId="256"/>
            <ac:picMk id="29" creationId="{A5A891F5-9D92-864E-B766-ECBA78821906}"/>
          </ac:picMkLst>
        </pc:picChg>
        <pc:picChg chg="mod">
          <ac:chgData name="Lester, Alice" userId="3488f9a2-0bc7-4793-a012-c42597f005ea" providerId="ADAL" clId="{22DD97B5-BB0B-493A-88EF-4F524A047145}" dt="2021-07-09T11:33:59.387" v="76" actId="1035"/>
          <ac:picMkLst>
            <pc:docMk/>
            <pc:sldMk cId="61558962" sldId="256"/>
            <ac:picMk id="30" creationId="{715E46EC-AC5A-3F4F-A58E-50CDDC2E4C2F}"/>
          </ac:picMkLst>
        </pc:picChg>
        <pc:picChg chg="mod">
          <ac:chgData name="Lester, Alice" userId="3488f9a2-0bc7-4793-a012-c42597f005ea" providerId="ADAL" clId="{22DD97B5-BB0B-493A-88EF-4F524A047145}" dt="2021-07-09T11:33:45.484" v="63" actId="1035"/>
          <ac:picMkLst>
            <pc:docMk/>
            <pc:sldMk cId="61558962" sldId="256"/>
            <ac:picMk id="33" creationId="{CF86008B-8F72-7443-BCA0-A088DBDA14D4}"/>
          </ac:picMkLst>
        </pc:picChg>
        <pc:picChg chg="mod">
          <ac:chgData name="Lester, Alice" userId="3488f9a2-0bc7-4793-a012-c42597f005ea" providerId="ADAL" clId="{22DD97B5-BB0B-493A-88EF-4F524A047145}" dt="2021-07-09T11:33:45.484" v="63" actId="1035"/>
          <ac:picMkLst>
            <pc:docMk/>
            <pc:sldMk cId="61558962" sldId="256"/>
            <ac:picMk id="37" creationId="{C85128FB-1D24-4942-A003-2D6B510C8161}"/>
          </ac:picMkLst>
        </pc:picChg>
        <pc:picChg chg="mod">
          <ac:chgData name="Lester, Alice" userId="3488f9a2-0bc7-4793-a012-c42597f005ea" providerId="ADAL" clId="{22DD97B5-BB0B-493A-88EF-4F524A047145}" dt="2021-07-09T11:33:45.484" v="63" actId="1035"/>
          <ac:picMkLst>
            <pc:docMk/>
            <pc:sldMk cId="61558962" sldId="256"/>
            <ac:picMk id="38" creationId="{14D156ED-540E-144D-A4BF-6E03EADF760E}"/>
          </ac:picMkLst>
        </pc:picChg>
        <pc:picChg chg="mod">
          <ac:chgData name="Lester, Alice" userId="3488f9a2-0bc7-4793-a012-c42597f005ea" providerId="ADAL" clId="{22DD97B5-BB0B-493A-88EF-4F524A047145}" dt="2021-07-09T11:33:45.484" v="63" actId="1035"/>
          <ac:picMkLst>
            <pc:docMk/>
            <pc:sldMk cId="61558962" sldId="256"/>
            <ac:picMk id="40" creationId="{715A3B9B-F91C-E641-9A16-03A9897ACE70}"/>
          </ac:picMkLst>
        </pc:picChg>
        <pc:picChg chg="mod">
          <ac:chgData name="Lester, Alice" userId="3488f9a2-0bc7-4793-a012-c42597f005ea" providerId="ADAL" clId="{22DD97B5-BB0B-493A-88EF-4F524A047145}" dt="2021-07-09T11:33:45.484" v="63" actId="1035"/>
          <ac:picMkLst>
            <pc:docMk/>
            <pc:sldMk cId="61558962" sldId="256"/>
            <ac:picMk id="43" creationId="{188AECD4-EE6A-0246-88EF-0D22C45B76DC}"/>
          </ac:picMkLst>
        </pc:picChg>
        <pc:picChg chg="mod">
          <ac:chgData name="Lester, Alice" userId="3488f9a2-0bc7-4793-a012-c42597f005ea" providerId="ADAL" clId="{22DD97B5-BB0B-493A-88EF-4F524A047145}" dt="2021-07-09T11:33:45.484" v="63" actId="1035"/>
          <ac:picMkLst>
            <pc:docMk/>
            <pc:sldMk cId="61558962" sldId="256"/>
            <ac:picMk id="44" creationId="{65F2E42F-161D-E340-BCCF-48CAE280CC78}"/>
          </ac:picMkLst>
        </pc:picChg>
        <pc:picChg chg="mod">
          <ac:chgData name="Lester, Alice" userId="3488f9a2-0bc7-4793-a012-c42597f005ea" providerId="ADAL" clId="{22DD97B5-BB0B-493A-88EF-4F524A047145}" dt="2021-07-09T11:33:59.387" v="76" actId="1035"/>
          <ac:picMkLst>
            <pc:docMk/>
            <pc:sldMk cId="61558962" sldId="256"/>
            <ac:picMk id="48" creationId="{2E0CC64F-2CDD-3A43-9026-EF5968A475C2}"/>
          </ac:picMkLst>
        </pc:picChg>
        <pc:picChg chg="mod">
          <ac:chgData name="Lester, Alice" userId="3488f9a2-0bc7-4793-a012-c42597f005ea" providerId="ADAL" clId="{22DD97B5-BB0B-493A-88EF-4F524A047145}" dt="2021-07-09T11:33:59.387" v="76" actId="1035"/>
          <ac:picMkLst>
            <pc:docMk/>
            <pc:sldMk cId="61558962" sldId="256"/>
            <ac:picMk id="50" creationId="{D8DD51CA-C004-EB49-BA3B-299F8ACC9EFD}"/>
          </ac:picMkLst>
        </pc:picChg>
        <pc:picChg chg="mod">
          <ac:chgData name="Lester, Alice" userId="3488f9a2-0bc7-4793-a012-c42597f005ea" providerId="ADAL" clId="{22DD97B5-BB0B-493A-88EF-4F524A047145}" dt="2021-07-09T11:33:59.387" v="76" actId="1035"/>
          <ac:picMkLst>
            <pc:docMk/>
            <pc:sldMk cId="61558962" sldId="256"/>
            <ac:picMk id="51" creationId="{8608F8B3-D991-9345-B191-42917D18FF24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14EC-D2DB-6148-8FF0-E0D73BF70C38}" type="datetimeFigureOut">
              <a:rPr lang="en-US" smtClean="0"/>
              <a:t>7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885-DB9A-1744-AE8F-CE075742B0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661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14EC-D2DB-6148-8FF0-E0D73BF70C38}" type="datetimeFigureOut">
              <a:rPr lang="en-US" smtClean="0"/>
              <a:t>7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885-DB9A-1744-AE8F-CE075742B0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14888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14EC-D2DB-6148-8FF0-E0D73BF70C38}" type="datetimeFigureOut">
              <a:rPr lang="en-US" smtClean="0"/>
              <a:t>7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885-DB9A-1744-AE8F-CE075742B0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4785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14EC-D2DB-6148-8FF0-E0D73BF70C38}" type="datetimeFigureOut">
              <a:rPr lang="en-US" smtClean="0"/>
              <a:t>7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885-DB9A-1744-AE8F-CE075742B0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605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14EC-D2DB-6148-8FF0-E0D73BF70C38}" type="datetimeFigureOut">
              <a:rPr lang="en-US" smtClean="0"/>
              <a:t>7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885-DB9A-1744-AE8F-CE075742B0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5767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14EC-D2DB-6148-8FF0-E0D73BF70C38}" type="datetimeFigureOut">
              <a:rPr lang="en-US" smtClean="0"/>
              <a:t>7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885-DB9A-1744-AE8F-CE075742B0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754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14EC-D2DB-6148-8FF0-E0D73BF70C38}" type="datetimeFigureOut">
              <a:rPr lang="en-US" smtClean="0"/>
              <a:t>7/1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885-DB9A-1744-AE8F-CE075742B0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2301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14EC-D2DB-6148-8FF0-E0D73BF70C38}" type="datetimeFigureOut">
              <a:rPr lang="en-US" smtClean="0"/>
              <a:t>7/1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885-DB9A-1744-AE8F-CE075742B0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4376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14EC-D2DB-6148-8FF0-E0D73BF70C38}" type="datetimeFigureOut">
              <a:rPr lang="en-US" smtClean="0"/>
              <a:t>7/1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885-DB9A-1744-AE8F-CE075742B0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958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14EC-D2DB-6148-8FF0-E0D73BF70C38}" type="datetimeFigureOut">
              <a:rPr lang="en-US" smtClean="0"/>
              <a:t>7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885-DB9A-1744-AE8F-CE075742B0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97248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8714EC-D2DB-6148-8FF0-E0D73BF70C38}" type="datetimeFigureOut">
              <a:rPr lang="en-US" smtClean="0"/>
              <a:t>7/1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486885-DB9A-1744-AE8F-CE075742B0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5992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8714EC-D2DB-6148-8FF0-E0D73BF70C38}" type="datetimeFigureOut">
              <a:rPr lang="en-US" smtClean="0"/>
              <a:t>7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486885-DB9A-1744-AE8F-CE075742B0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019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5">
            <a:extLst>
              <a:ext uri="{FF2B5EF4-FFF2-40B4-BE49-F238E27FC236}">
                <a16:creationId xmlns:a16="http://schemas.microsoft.com/office/drawing/2014/main" id="{37C27077-ED97-A742-A934-956B2B0357E2}"/>
              </a:ext>
            </a:extLst>
          </p:cNvPr>
          <p:cNvSpPr txBox="1"/>
          <p:nvPr/>
        </p:nvSpPr>
        <p:spPr>
          <a:xfrm>
            <a:off x="1582164" y="374706"/>
            <a:ext cx="806564" cy="261977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GB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L - 0</a:t>
            </a:r>
            <a:endParaRPr lang="en-GB" sz="16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 Box 15">
            <a:extLst>
              <a:ext uri="{FF2B5EF4-FFF2-40B4-BE49-F238E27FC236}">
                <a16:creationId xmlns:a16="http://schemas.microsoft.com/office/drawing/2014/main" id="{2BB66600-AC4F-DE4E-9AF4-D919A059A21D}"/>
              </a:ext>
            </a:extLst>
          </p:cNvPr>
          <p:cNvSpPr txBox="1"/>
          <p:nvPr/>
        </p:nvSpPr>
        <p:spPr>
          <a:xfrm>
            <a:off x="106798" y="69278"/>
            <a:ext cx="2687408" cy="261977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GB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 </a:t>
            </a:r>
            <a:endParaRPr lang="en-GB" sz="16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2E25A6A-F788-7E4C-9A22-F6BDDE35499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0423" t="4444" b="71431"/>
          <a:stretch/>
        </p:blipFill>
        <p:spPr>
          <a:xfrm>
            <a:off x="2818401" y="189565"/>
            <a:ext cx="889118" cy="663115"/>
          </a:xfrm>
          <a:prstGeom prst="rect">
            <a:avLst/>
          </a:prstGeom>
        </p:spPr>
      </p:pic>
      <p:sp>
        <p:nvSpPr>
          <p:cNvPr id="7" name="Text Box 15">
            <a:extLst>
              <a:ext uri="{FF2B5EF4-FFF2-40B4-BE49-F238E27FC236}">
                <a16:creationId xmlns:a16="http://schemas.microsoft.com/office/drawing/2014/main" id="{DACAA21D-1AFA-4C47-BE6E-7CDED85A848D}"/>
              </a:ext>
            </a:extLst>
          </p:cNvPr>
          <p:cNvSpPr txBox="1"/>
          <p:nvPr/>
        </p:nvSpPr>
        <p:spPr>
          <a:xfrm>
            <a:off x="5120968" y="383240"/>
            <a:ext cx="939145" cy="261977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GB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L - 60</a:t>
            </a:r>
            <a:endParaRPr lang="en-GB" sz="16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 descr="Chart, scatter chart&#10;&#10;Description automatically generated">
            <a:extLst>
              <a:ext uri="{FF2B5EF4-FFF2-40B4-BE49-F238E27FC236}">
                <a16:creationId xmlns:a16="http://schemas.microsoft.com/office/drawing/2014/main" id="{1E004FD1-2668-7C4F-8744-C4A228A4C3C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867" r="6678"/>
          <a:stretch/>
        </p:blipFill>
        <p:spPr>
          <a:xfrm>
            <a:off x="642100" y="1155854"/>
            <a:ext cx="2515277" cy="167971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C0EF23F-3BBE-A646-93F5-B9F8870F411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773" r="7838"/>
          <a:stretch/>
        </p:blipFill>
        <p:spPr>
          <a:xfrm>
            <a:off x="567192" y="3999132"/>
            <a:ext cx="2439758" cy="1755309"/>
          </a:xfrm>
          <a:prstGeom prst="rect">
            <a:avLst/>
          </a:prstGeom>
        </p:spPr>
      </p:pic>
      <p:pic>
        <p:nvPicPr>
          <p:cNvPr id="10" name="Picture 9" descr="Chart, scatter chart&#10;&#10;Description automatically generated">
            <a:extLst>
              <a:ext uri="{FF2B5EF4-FFF2-40B4-BE49-F238E27FC236}">
                <a16:creationId xmlns:a16="http://schemas.microsoft.com/office/drawing/2014/main" id="{CC33927B-0CFA-E54D-A7D0-84C610FCCBD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9134" t="5300" r="8112"/>
          <a:stretch/>
        </p:blipFill>
        <p:spPr>
          <a:xfrm>
            <a:off x="586751" y="7183126"/>
            <a:ext cx="2437315" cy="1693402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49433337-BA49-1843-BB61-52221D572AFB}"/>
              </a:ext>
            </a:extLst>
          </p:cNvPr>
          <p:cNvSpPr txBox="1"/>
          <p:nvPr/>
        </p:nvSpPr>
        <p:spPr>
          <a:xfrm>
            <a:off x="898302" y="2889369"/>
            <a:ext cx="2244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% Chang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eutrophil Coun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927FBB8-AE6C-5440-A9BF-17DF9D31A044}"/>
              </a:ext>
            </a:extLst>
          </p:cNvPr>
          <p:cNvSpPr txBox="1"/>
          <p:nvPr/>
        </p:nvSpPr>
        <p:spPr>
          <a:xfrm rot="16200000">
            <a:off x="-672659" y="4880630"/>
            <a:ext cx="20192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% Change  PMA-stimulated ROS productio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0E00467-C636-774B-A1BC-E53DBC4A7B0D}"/>
              </a:ext>
            </a:extLst>
          </p:cNvPr>
          <p:cNvSpPr txBox="1"/>
          <p:nvPr/>
        </p:nvSpPr>
        <p:spPr>
          <a:xfrm>
            <a:off x="898302" y="5813078"/>
            <a:ext cx="2244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% Chang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nocyte Coun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35305E8-B66D-CF4C-8199-7EB7DCF423F6}"/>
              </a:ext>
            </a:extLst>
          </p:cNvPr>
          <p:cNvSpPr txBox="1"/>
          <p:nvPr/>
        </p:nvSpPr>
        <p:spPr>
          <a:xfrm>
            <a:off x="1276101" y="752787"/>
            <a:ext cx="85090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r = 0.302</a:t>
            </a:r>
          </a:p>
          <a:p>
            <a:r>
              <a:rPr lang="en-US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 = 0.316</a:t>
            </a:r>
            <a:endParaRPr 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1D726E6E-6D2B-5D4E-999E-4DE0C46E90E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15183" y="872957"/>
            <a:ext cx="219106" cy="190527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7F256820-5BCB-E247-B430-7F146D97703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35530" y="796751"/>
            <a:ext cx="285790" cy="238158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58EC5714-0AA5-A94A-9E1A-15260F5AC35C}"/>
              </a:ext>
            </a:extLst>
          </p:cNvPr>
          <p:cNvSpPr txBox="1"/>
          <p:nvPr/>
        </p:nvSpPr>
        <p:spPr>
          <a:xfrm>
            <a:off x="2082726" y="753032"/>
            <a:ext cx="84475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r = 0.709</a:t>
            </a:r>
          </a:p>
          <a:p>
            <a:r>
              <a:rPr lang="en-US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 = 0.007</a:t>
            </a:r>
            <a:endParaRPr 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3D711DD-F66D-764F-997A-F3751DD069E3}"/>
              </a:ext>
            </a:extLst>
          </p:cNvPr>
          <p:cNvSpPr txBox="1"/>
          <p:nvPr/>
        </p:nvSpPr>
        <p:spPr>
          <a:xfrm rot="16200000">
            <a:off x="-672659" y="7829990"/>
            <a:ext cx="20192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% Change  PMA-stimulated ROS productio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 Box 15">
            <a:extLst>
              <a:ext uri="{FF2B5EF4-FFF2-40B4-BE49-F238E27FC236}">
                <a16:creationId xmlns:a16="http://schemas.microsoft.com/office/drawing/2014/main" id="{967CDFA8-ED1C-5643-9D72-1CBB62FD859C}"/>
              </a:ext>
            </a:extLst>
          </p:cNvPr>
          <p:cNvSpPr txBox="1"/>
          <p:nvPr/>
        </p:nvSpPr>
        <p:spPr>
          <a:xfrm>
            <a:off x="106117" y="729117"/>
            <a:ext cx="312422" cy="261977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GB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endParaRPr lang="en-GB" sz="14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 Box 15">
            <a:extLst>
              <a:ext uri="{FF2B5EF4-FFF2-40B4-BE49-F238E27FC236}">
                <a16:creationId xmlns:a16="http://schemas.microsoft.com/office/drawing/2014/main" id="{53B1B4ED-755B-0E4A-AF5D-D7D4191D02F4}"/>
              </a:ext>
            </a:extLst>
          </p:cNvPr>
          <p:cNvSpPr txBox="1"/>
          <p:nvPr/>
        </p:nvSpPr>
        <p:spPr>
          <a:xfrm>
            <a:off x="106117" y="3622064"/>
            <a:ext cx="312422" cy="261977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GB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endParaRPr lang="en-GB" sz="14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 Box 15">
            <a:extLst>
              <a:ext uri="{FF2B5EF4-FFF2-40B4-BE49-F238E27FC236}">
                <a16:creationId xmlns:a16="http://schemas.microsoft.com/office/drawing/2014/main" id="{34B23353-9B1E-9F4D-A4EC-2A2056CD507E}"/>
              </a:ext>
            </a:extLst>
          </p:cNvPr>
          <p:cNvSpPr txBox="1"/>
          <p:nvPr/>
        </p:nvSpPr>
        <p:spPr>
          <a:xfrm>
            <a:off x="106117" y="6556593"/>
            <a:ext cx="312422" cy="261977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GB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endParaRPr lang="en-GB" sz="14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2D5BBD3-46DE-EF42-BA71-3610069A746D}"/>
              </a:ext>
            </a:extLst>
          </p:cNvPr>
          <p:cNvSpPr txBox="1"/>
          <p:nvPr/>
        </p:nvSpPr>
        <p:spPr>
          <a:xfrm rot="16200000">
            <a:off x="-672658" y="1929652"/>
            <a:ext cx="20192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% Change  PMA-stimulated ROS productio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3F0228B-0394-8E4D-B5FB-1F604593B172}"/>
              </a:ext>
            </a:extLst>
          </p:cNvPr>
          <p:cNvSpPr txBox="1"/>
          <p:nvPr/>
        </p:nvSpPr>
        <p:spPr>
          <a:xfrm>
            <a:off x="1273544" y="3609665"/>
            <a:ext cx="85090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r = 0.176</a:t>
            </a:r>
          </a:p>
          <a:p>
            <a:r>
              <a:rPr lang="en-US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 = 0.564</a:t>
            </a:r>
            <a:endParaRPr 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9C710974-4E21-DB4F-9781-F939653FDF3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12626" y="3729835"/>
            <a:ext cx="219106" cy="190527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7B8EAF02-A305-7342-BBF5-D0943D94B6E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32973" y="3653629"/>
            <a:ext cx="285790" cy="238158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736C2FB6-B0F6-5F47-8259-1E45AE54E154}"/>
              </a:ext>
            </a:extLst>
          </p:cNvPr>
          <p:cNvSpPr txBox="1"/>
          <p:nvPr/>
        </p:nvSpPr>
        <p:spPr>
          <a:xfrm>
            <a:off x="2080169" y="3609910"/>
            <a:ext cx="84475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r = 0.590</a:t>
            </a:r>
          </a:p>
          <a:p>
            <a:r>
              <a:rPr lang="en-US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 = 0.034</a:t>
            </a:r>
            <a:endParaRPr 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6A42009-361A-F94A-AFBC-BFE602C05C6C}"/>
              </a:ext>
            </a:extLst>
          </p:cNvPr>
          <p:cNvSpPr txBox="1"/>
          <p:nvPr/>
        </p:nvSpPr>
        <p:spPr>
          <a:xfrm>
            <a:off x="1243764" y="6596147"/>
            <a:ext cx="85090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r = 0.357</a:t>
            </a:r>
          </a:p>
          <a:p>
            <a:r>
              <a:rPr lang="en-US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 = 0.231</a:t>
            </a:r>
            <a:endParaRPr 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A5A891F5-9D92-864E-B766-ECBA7882190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82846" y="6716317"/>
            <a:ext cx="219106" cy="190527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715E46EC-AC5A-3F4F-A58E-50CDDC2E4C2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03193" y="6640111"/>
            <a:ext cx="285790" cy="238158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828CC8D2-48CD-1E45-B4F1-4A69BF460A66}"/>
              </a:ext>
            </a:extLst>
          </p:cNvPr>
          <p:cNvSpPr txBox="1"/>
          <p:nvPr/>
        </p:nvSpPr>
        <p:spPr>
          <a:xfrm>
            <a:off x="2050389" y="6596392"/>
            <a:ext cx="84475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r = 0.609</a:t>
            </a:r>
          </a:p>
          <a:p>
            <a:r>
              <a:rPr lang="en-US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 = 0.027</a:t>
            </a:r>
            <a:endParaRPr 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F9959CC-3028-1443-93DF-1DF0E4CCBD88}"/>
              </a:ext>
            </a:extLst>
          </p:cNvPr>
          <p:cNvSpPr txBox="1"/>
          <p:nvPr/>
        </p:nvSpPr>
        <p:spPr>
          <a:xfrm>
            <a:off x="898302" y="8893596"/>
            <a:ext cx="2244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% Chang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latelet Count</a:t>
            </a:r>
          </a:p>
        </p:txBody>
      </p:sp>
      <p:pic>
        <p:nvPicPr>
          <p:cNvPr id="33" name="Picture 32" descr="Chart, scatter chart&#10;&#10;Description automatically generated">
            <a:extLst>
              <a:ext uri="{FF2B5EF4-FFF2-40B4-BE49-F238E27FC236}">
                <a16:creationId xmlns:a16="http://schemas.microsoft.com/office/drawing/2014/main" id="{CF86008B-8F72-7443-BCA0-A088DBDA14D4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9718" t="8476" r="8584"/>
          <a:stretch/>
        </p:blipFill>
        <p:spPr>
          <a:xfrm>
            <a:off x="4203044" y="1150876"/>
            <a:ext cx="2558870" cy="1740455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F5637A9B-0192-754D-93AE-3463389DDBC9}"/>
              </a:ext>
            </a:extLst>
          </p:cNvPr>
          <p:cNvSpPr txBox="1"/>
          <p:nvPr/>
        </p:nvSpPr>
        <p:spPr>
          <a:xfrm>
            <a:off x="4475826" y="2889369"/>
            <a:ext cx="2244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% Chang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eutrophil Count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B367C68-B7BE-8842-A71E-321F98B6A4D2}"/>
              </a:ext>
            </a:extLst>
          </p:cNvPr>
          <p:cNvSpPr txBox="1"/>
          <p:nvPr/>
        </p:nvSpPr>
        <p:spPr>
          <a:xfrm rot="16200000">
            <a:off x="2827371" y="1775056"/>
            <a:ext cx="20192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% Change  PMA-stimulated ROS productio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AD97018-F7CD-AC4C-9B72-4792A432D5CF}"/>
              </a:ext>
            </a:extLst>
          </p:cNvPr>
          <p:cNvSpPr txBox="1"/>
          <p:nvPr/>
        </p:nvSpPr>
        <p:spPr>
          <a:xfrm>
            <a:off x="4864555" y="754820"/>
            <a:ext cx="85090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r = 0.621</a:t>
            </a:r>
          </a:p>
          <a:p>
            <a:r>
              <a:rPr lang="en-US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 = 0.024</a:t>
            </a:r>
            <a:endParaRPr 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C85128FB-1D24-4942-A003-2D6B510C816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03637" y="874990"/>
            <a:ext cx="219106" cy="190527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14D156ED-540E-144D-A4BF-6E03EADF760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523984" y="798784"/>
            <a:ext cx="285790" cy="238158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68B9772A-F154-234A-9961-00344510CB86}"/>
              </a:ext>
            </a:extLst>
          </p:cNvPr>
          <p:cNvSpPr txBox="1"/>
          <p:nvPr/>
        </p:nvSpPr>
        <p:spPr>
          <a:xfrm>
            <a:off x="5671180" y="755065"/>
            <a:ext cx="84475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r = 0.687</a:t>
            </a:r>
          </a:p>
          <a:p>
            <a:r>
              <a:rPr lang="en-US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 = 0.01</a:t>
            </a:r>
            <a:endParaRPr 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Picture 39" descr="Chart, scatter chart&#10;&#10;Description automatically generated">
            <a:extLst>
              <a:ext uri="{FF2B5EF4-FFF2-40B4-BE49-F238E27FC236}">
                <a16:creationId xmlns:a16="http://schemas.microsoft.com/office/drawing/2014/main" id="{715A3B9B-F91C-E641-9A16-03A9897ACE70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0003" t="8937" r="9809"/>
          <a:stretch/>
        </p:blipFill>
        <p:spPr>
          <a:xfrm>
            <a:off x="4101408" y="4014631"/>
            <a:ext cx="2630614" cy="1813748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88E0150E-9FC4-834B-A0F0-63C3F6E314FB}"/>
              </a:ext>
            </a:extLst>
          </p:cNvPr>
          <p:cNvSpPr txBox="1"/>
          <p:nvPr/>
        </p:nvSpPr>
        <p:spPr>
          <a:xfrm>
            <a:off x="4856602" y="3622010"/>
            <a:ext cx="85090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r = 0.376</a:t>
            </a:r>
          </a:p>
          <a:p>
            <a:r>
              <a:rPr lang="en-US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 = 0.206</a:t>
            </a:r>
            <a:endParaRPr 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188AECD4-EE6A-0246-88EF-0D22C45B76D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95684" y="3742180"/>
            <a:ext cx="219106" cy="190527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65F2E42F-161D-E340-BCCF-48CAE280CC7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516031" y="3665974"/>
            <a:ext cx="285790" cy="238158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A19481F2-A56C-C346-A1E8-26E31FBBE82A}"/>
              </a:ext>
            </a:extLst>
          </p:cNvPr>
          <p:cNvSpPr txBox="1"/>
          <p:nvPr/>
        </p:nvSpPr>
        <p:spPr>
          <a:xfrm>
            <a:off x="5663227" y="3622255"/>
            <a:ext cx="84475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r = 0.193</a:t>
            </a:r>
          </a:p>
          <a:p>
            <a:r>
              <a:rPr lang="en-US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 = 0.527</a:t>
            </a:r>
            <a:endParaRPr 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C9455CF-5A76-0C49-969D-A6A22128FF0D}"/>
              </a:ext>
            </a:extLst>
          </p:cNvPr>
          <p:cNvSpPr txBox="1"/>
          <p:nvPr/>
        </p:nvSpPr>
        <p:spPr>
          <a:xfrm rot="16200000">
            <a:off x="2827371" y="4878049"/>
            <a:ext cx="20192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% Change  PMA-stimulated ROS productio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59A0764-3401-A447-8656-90777658E23A}"/>
              </a:ext>
            </a:extLst>
          </p:cNvPr>
          <p:cNvSpPr txBox="1"/>
          <p:nvPr/>
        </p:nvSpPr>
        <p:spPr>
          <a:xfrm>
            <a:off x="4444829" y="5810497"/>
            <a:ext cx="2244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% Chang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onocyte Count</a:t>
            </a:r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2E0CC64F-2CDD-3A43-9026-EF5968A475C2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8673" t="7597" r="7444"/>
          <a:stretch/>
        </p:blipFill>
        <p:spPr>
          <a:xfrm>
            <a:off x="4098370" y="6992426"/>
            <a:ext cx="2668915" cy="1784993"/>
          </a:xfrm>
          <a:prstGeom prst="rect">
            <a:avLst/>
          </a:prstGeom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7F95FB64-D51A-6B4B-A034-3E2CC2187AD1}"/>
              </a:ext>
            </a:extLst>
          </p:cNvPr>
          <p:cNvSpPr txBox="1"/>
          <p:nvPr/>
        </p:nvSpPr>
        <p:spPr>
          <a:xfrm>
            <a:off x="4864161" y="6590346"/>
            <a:ext cx="85090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r = 0.352</a:t>
            </a:r>
          </a:p>
          <a:p>
            <a:r>
              <a:rPr lang="en-US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 = 0.239</a:t>
            </a:r>
            <a:endParaRPr 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D8DD51CA-C004-EB49-BA3B-299F8ACC9EF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03243" y="6710516"/>
            <a:ext cx="219106" cy="190527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8608F8B3-D991-9345-B191-42917D18FF2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523590" y="6634310"/>
            <a:ext cx="285790" cy="238158"/>
          </a:xfrm>
          <a:prstGeom prst="rect">
            <a:avLst/>
          </a:prstGeom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F6EC5191-83B8-F74E-BEC0-D23833F0F022}"/>
              </a:ext>
            </a:extLst>
          </p:cNvPr>
          <p:cNvSpPr txBox="1"/>
          <p:nvPr/>
        </p:nvSpPr>
        <p:spPr>
          <a:xfrm>
            <a:off x="5670786" y="6590591"/>
            <a:ext cx="84475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r = - 0.038</a:t>
            </a:r>
          </a:p>
          <a:p>
            <a:r>
              <a:rPr lang="en-US" sz="105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 = 0.901</a:t>
            </a:r>
            <a:endParaRPr lang="en-US" sz="105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CFBFBB3-EC76-7C44-A3F4-A083465EF323}"/>
              </a:ext>
            </a:extLst>
          </p:cNvPr>
          <p:cNvSpPr txBox="1"/>
          <p:nvPr/>
        </p:nvSpPr>
        <p:spPr>
          <a:xfrm rot="16200000">
            <a:off x="2827371" y="7827409"/>
            <a:ext cx="20192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% Change  PMA-stimulated ROS productio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51CEDEFB-FD38-AF4C-B7EB-B26402F23516}"/>
              </a:ext>
            </a:extLst>
          </p:cNvPr>
          <p:cNvSpPr txBox="1"/>
          <p:nvPr/>
        </p:nvSpPr>
        <p:spPr>
          <a:xfrm>
            <a:off x="4398332" y="8893596"/>
            <a:ext cx="2244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% Chang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latelet Count</a:t>
            </a:r>
          </a:p>
        </p:txBody>
      </p:sp>
      <p:sp>
        <p:nvSpPr>
          <p:cNvPr id="55" name="Text Box 15">
            <a:extLst>
              <a:ext uri="{FF2B5EF4-FFF2-40B4-BE49-F238E27FC236}">
                <a16:creationId xmlns:a16="http://schemas.microsoft.com/office/drawing/2014/main" id="{30122387-E1B4-3F4C-99E2-A1A8990879C7}"/>
              </a:ext>
            </a:extLst>
          </p:cNvPr>
          <p:cNvSpPr txBox="1"/>
          <p:nvPr/>
        </p:nvSpPr>
        <p:spPr>
          <a:xfrm>
            <a:off x="3637150" y="726535"/>
            <a:ext cx="312422" cy="261977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GB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</a:t>
            </a:r>
            <a:endParaRPr lang="en-GB" sz="14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 Box 15">
            <a:extLst>
              <a:ext uri="{FF2B5EF4-FFF2-40B4-BE49-F238E27FC236}">
                <a16:creationId xmlns:a16="http://schemas.microsoft.com/office/drawing/2014/main" id="{FD66483F-9E84-E940-84AB-641A47080BCE}"/>
              </a:ext>
            </a:extLst>
          </p:cNvPr>
          <p:cNvSpPr txBox="1"/>
          <p:nvPr/>
        </p:nvSpPr>
        <p:spPr>
          <a:xfrm>
            <a:off x="3637150" y="3619482"/>
            <a:ext cx="312422" cy="261977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GB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endParaRPr lang="en-GB" sz="14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 Box 15">
            <a:extLst>
              <a:ext uri="{FF2B5EF4-FFF2-40B4-BE49-F238E27FC236}">
                <a16:creationId xmlns:a16="http://schemas.microsoft.com/office/drawing/2014/main" id="{8697A56B-45C5-0449-AF4F-763306A2DD77}"/>
              </a:ext>
            </a:extLst>
          </p:cNvPr>
          <p:cNvSpPr txBox="1"/>
          <p:nvPr/>
        </p:nvSpPr>
        <p:spPr>
          <a:xfrm>
            <a:off x="3637150" y="6554011"/>
            <a:ext cx="312422" cy="261977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GB" sz="16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endParaRPr lang="en-GB" sz="14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02933B5-849B-46DC-A933-ED2D0F0E14A4}"/>
              </a:ext>
            </a:extLst>
          </p:cNvPr>
          <p:cNvSpPr txBox="1"/>
          <p:nvPr/>
        </p:nvSpPr>
        <p:spPr>
          <a:xfrm>
            <a:off x="68702" y="9428202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1</a:t>
            </a:r>
            <a:r>
              <a:rPr lang="en-GB" sz="9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GB" sz="9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</a:t>
            </a:r>
            <a:r>
              <a:rPr lang="en-GB" sz="9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ows the correlation between the percentage change in each cell type and the percentage change in PMA-stimulated ROS production from baseline to 0 (immediately post exercise) and from baseline to 60 minutes post exercise.</a:t>
            </a:r>
          </a:p>
        </p:txBody>
      </p:sp>
    </p:spTree>
    <p:extLst>
      <p:ext uri="{BB962C8B-B14F-4D97-AF65-F5344CB8AC3E}">
        <p14:creationId xmlns:p14="http://schemas.microsoft.com/office/powerpoint/2010/main" val="615589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24BC434B133B84CAEDA9AFCBA631A0E" ma:contentTypeVersion="13" ma:contentTypeDescription="Create a new document." ma:contentTypeScope="" ma:versionID="4e3cc998f63e22c6a6d7dc3084113c31">
  <xsd:schema xmlns:xsd="http://www.w3.org/2001/XMLSchema" xmlns:xs="http://www.w3.org/2001/XMLSchema" xmlns:p="http://schemas.microsoft.com/office/2006/metadata/properties" xmlns:ns3="e468627a-5903-416e-9d64-e86fe941a2a1" xmlns:ns4="fab05256-bbe6-4e0e-a5cd-dcf27327219d" targetNamespace="http://schemas.microsoft.com/office/2006/metadata/properties" ma:root="true" ma:fieldsID="fda5a811a795bb5d77f70a9c1232d8a6" ns3:_="" ns4:_="">
    <xsd:import namespace="e468627a-5903-416e-9d64-e86fe941a2a1"/>
    <xsd:import namespace="fab05256-bbe6-4e0e-a5cd-dcf27327219d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DateTaken" minOccurs="0"/>
                <xsd:element ref="ns4:MediaServiceAutoTags" minOccurs="0"/>
                <xsd:element ref="ns4:MediaServiceGenerationTime" minOccurs="0"/>
                <xsd:element ref="ns4:MediaServiceEventHashCode" minOccurs="0"/>
                <xsd:element ref="ns4:MediaServiceOCR" minOccurs="0"/>
                <xsd:element ref="ns4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468627a-5903-416e-9d64-e86fe941a2a1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Sharing Hint Hash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ab05256-bbe6-4e0e-a5cd-dcf27327219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2FCE9D8E-9DA5-4C9F-A585-396D9DCDB128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765C09FB-A07E-434E-BDF9-5031729D500F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F0A9976-459E-496E-8598-B5C8E333EBC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468627a-5903-416e-9d64-e86fe941a2a1"/>
    <ds:schemaRef ds:uri="fab05256-bbe6-4e0e-a5cd-dcf27327219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8</TotalTime>
  <Words>188</Words>
  <Application>Microsoft Macintosh PowerPoint</Application>
  <PresentationFormat>A4 Paper (210x297 mm)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mes Turner</dc:creator>
  <cp:lastModifiedBy>James Turner</cp:lastModifiedBy>
  <cp:revision>9</cp:revision>
  <dcterms:created xsi:type="dcterms:W3CDTF">2021-07-03T06:17:18Z</dcterms:created>
  <dcterms:modified xsi:type="dcterms:W3CDTF">2021-07-12T08:23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24BC434B133B84CAEDA9AFCBA631A0E</vt:lpwstr>
  </property>
</Properties>
</file>